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0" r:id="rId2"/>
    <p:sldId id="281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D4CFF"/>
    <a:srgbClr val="A473FF"/>
    <a:srgbClr val="FF9C4B"/>
    <a:srgbClr val="A1C447"/>
    <a:srgbClr val="8B961D"/>
    <a:srgbClr val="68CF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85" autoAdjust="0"/>
    <p:restoredTop sz="94852" autoAdjust="0"/>
  </p:normalViewPr>
  <p:slideViewPr>
    <p:cSldViewPr snapToGrid="0" snapToObjects="1">
      <p:cViewPr>
        <p:scale>
          <a:sx n="152" d="100"/>
          <a:sy n="152" d="100"/>
        </p:scale>
        <p:origin x="-1304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DA6643-8E32-9A4C-AD52-F8801A2A5AF1}" type="datetimeFigureOut">
              <a:rPr lang="en-US" smtClean="0"/>
              <a:t>2/2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CE494E-83A9-D94F-9BBD-407B3C2482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454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37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084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069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93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529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177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129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030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587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29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958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D9B88-68D5-6043-A568-A8B8D3B4C326}" type="datetimeFigureOut">
              <a:rPr lang="en-US" smtClean="0"/>
              <a:pPr/>
              <a:t>2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E4D0E-3788-0746-A226-DC2064330C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00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3909884"/>
              </p:ext>
            </p:extLst>
          </p:nvPr>
        </p:nvGraphicFramePr>
        <p:xfrm>
          <a:off x="158750" y="305240"/>
          <a:ext cx="6472904" cy="7881496"/>
        </p:xfrm>
        <a:graphic>
          <a:graphicData uri="http://schemas.openxmlformats.org/drawingml/2006/table">
            <a:tbl>
              <a:tblPr/>
              <a:tblGrid>
                <a:gridCol w="692875"/>
                <a:gridCol w="1159036"/>
                <a:gridCol w="2439757"/>
                <a:gridCol w="913176"/>
                <a:gridCol w="1268060"/>
              </a:tblGrid>
              <a:tr h="290216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train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elevant Genotype/Indicated in figure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Genotyp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ourc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ur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T mHtt103Q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MAT</a:t>
                      </a:r>
                      <a:r>
                        <a:rPr lang="en-US" sz="700" b="1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a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his3Δ::kanMX4 can1Δ::STE2pr-Sp_his5 lyp1Δ ura3Δ0 met15Δ0 pYES2</a:t>
                      </a:r>
                      <a:r>
                        <a:rPr lang="en-US" sz="700" b="0" i="1" u="none" strike="noStrike" kern="1200" baseline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mHtt103QP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GF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1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,1d,1e, Fig.2a-e, 2g,   Fig.3b,3f,3g, Fig.S1b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1 ltn1Δ::kanMX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1b,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Fig.2a-e, Fig.3c,3f,3g, Fig.S1b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qc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1 rqc1Δ::kan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,2d,2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ae2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1 tae2Δ::kan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,2d,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2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tae2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2 tae2Δ::nat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,2d,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2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qc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tae2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3 tae2Δ::nat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,2d,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q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1 rnq1Δ::kan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1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q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5 ltn1Δ::nat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00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-848 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1001 hsf1-848:kan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d,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,2g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WT</a:t>
                      </a:r>
                      <a:r>
                        <a:rPr lang="en-US" sz="700" b="0" i="1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MAT</a:t>
                      </a:r>
                      <a:r>
                        <a:rPr lang="en-US" sz="700" b="1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a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his3Δ::kanMX4 can1Δ::STE2pr-Sp_his5 lyp1Δ ura3Δ0 met15Δ0 pYES2-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1 ltn1Δ::kanMX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rqc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1 rqc1Δ::kanMX4</a:t>
                      </a:r>
                      <a:endParaRPr lang="en-US" sz="700" b="0" i="1" u="none" strike="noStrike" dirty="0" smtClean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ae2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1tae2Δ::kanMX4</a:t>
                      </a:r>
                      <a:endParaRPr lang="en-US" sz="700" b="0" i="1" u="none" strike="noStrike" dirty="0" smtClean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2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tae2Δ 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2 tae2Δ::natMX4</a:t>
                      </a:r>
                      <a:endParaRPr lang="en-US" sz="700" b="0" i="1" u="none" strike="noStrike" dirty="0" smtClean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2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rqc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tae2Δ 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3 tae2Δ::natMX4</a:t>
                      </a:r>
                      <a:endParaRPr lang="en-US" sz="700" b="0" i="1" u="none" strike="noStrike" dirty="0" smtClean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q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GF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1 rnq1Δ::kan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1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nq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GF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5 ltn1Δ::natMX4</a:t>
                      </a:r>
                      <a:endParaRPr lang="en-US" sz="700" b="0" i="1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e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110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hsf1-848 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GFP</a:t>
                      </a:r>
                      <a:endParaRPr lang="en-US" sz="700" b="0" i="1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YY2001 hsf1-848:kanMX4</a:t>
                      </a:r>
                      <a:endParaRPr lang="en-US" sz="700" b="0" i="1" u="none" strike="noStrike" dirty="0" smtClean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g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Y474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700" dirty="0"/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i="1" u="none" strike="noStrike" kern="1200" baseline="0" dirty="0" err="1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MAT</a:t>
                      </a:r>
                      <a:r>
                        <a:rPr lang="en-US" sz="700" b="1" i="1" u="none" strike="noStrike" kern="1200" baseline="0" dirty="0" err="1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a</a:t>
                      </a:r>
                      <a:r>
                        <a:rPr lang="en-US" sz="700" b="1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his3Δ1 leu2Δ0</a:t>
                      </a:r>
                      <a:r>
                        <a:rPr lang="en-US" sz="7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met15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0</a:t>
                      </a:r>
                      <a:r>
                        <a:rPr lang="en-US" sz="7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ura3Δ0 </a:t>
                      </a:r>
                      <a:endParaRPr lang="en-US" sz="700" dirty="0"/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ab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stock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700" dirty="0"/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0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 mHtt103Q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ltn1Δ::natMX4 pY2H-103QP-GFP pGAD-LTN1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0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LTN1-W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1542E mHtt103Q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ltn1Δ::natMX4 pY2H-103QP-GFP pGAD-LTN1</a:t>
                      </a:r>
                      <a:r>
                        <a:rPr lang="en-US" sz="7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W1542E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a,2b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1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Vector mHtt103Q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pY2H-103QP-GFP pRS416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d,2f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1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-R206S 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pY2H-103QP-GFP pRS416-TEF1-HSF1-R206S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</a:t>
                      </a:r>
                      <a:r>
                        <a:rPr lang="en-US" altLang="zh-CN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d,2f</a:t>
                      </a:r>
                      <a:endParaRPr lang="en-US" altLang="zh-CN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2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Vector GF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</a:t>
                      </a:r>
                      <a:r>
                        <a:rPr lang="en-US" sz="700" b="0" i="1" u="none" strike="noStrike" kern="1200" baseline="0" dirty="0" smtClean="0">
                          <a:solidFill>
                            <a:srgbClr val="000000"/>
                          </a:solidFill>
                          <a:latin typeface="Helvetica"/>
                          <a:ea typeface="+mn-ea"/>
                          <a:cs typeface="Helvetica"/>
                        </a:rPr>
                        <a:t>pY2H-GFP pRS416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f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2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-R206S GFP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</a:t>
                      </a:r>
                      <a:r>
                        <a:rPr lang="en-US" sz="700" b="0" i="1" u="none" strike="noStrike" kern="1200" baseline="0" dirty="0" smtClean="0">
                          <a:solidFill>
                            <a:srgbClr val="000000"/>
                          </a:solidFill>
                          <a:latin typeface="Helvetica"/>
                          <a:ea typeface="+mn-ea"/>
                          <a:cs typeface="Helvetica"/>
                        </a:rPr>
                        <a:t>pY2H-GFP pRS416-TEF1-HSF1-R206S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altLang="zh-CN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f</a:t>
                      </a:r>
                      <a:endParaRPr lang="en-US" altLang="zh-CN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23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UBC9</a:t>
                      </a:r>
                      <a:r>
                        <a:rPr lang="en-US" sz="1000" b="0" i="1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s</a:t>
                      </a:r>
                      <a:r>
                        <a:rPr lang="en-US" sz="10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0" i="1" u="none" strike="noStrike" baseline="30000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BY4741 pY2H-103QP-GFP  pESC-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UBC9</a:t>
                      </a:r>
                      <a:r>
                        <a:rPr lang="en-US" sz="1000" b="0" i="1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s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mCherry</a:t>
                      </a:r>
                      <a:endParaRPr lang="en-US" sz="700" b="0" i="1" u="none" strike="noStrike" baseline="0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3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303-1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fr-FR" sz="7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AT</a:t>
                      </a:r>
                      <a:r>
                        <a:rPr lang="fr-FR" sz="700" b="1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  <a:r>
                        <a:rPr lang="fr-FR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ade2–1 trp1-1 can1-100 leu2-3,112 his3-11,15 ura3–1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Eastmond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, 200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300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T 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303-1A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fr-FR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Y2H-103QP-GF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300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3001 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ltn1Δ::natMX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300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ΔCAD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fr-FR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3001 HSF1ΔCAD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::URA3</a:t>
                      </a:r>
                      <a:endParaRPr lang="en-US" sz="700" b="0" i="1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8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Y300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tn1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Δ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SF1ΔCAD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Htt103Q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Y3003 </a:t>
                      </a:r>
                      <a:r>
                        <a:rPr lang="en-US" sz="700" b="0" i="1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ltn1Δ::natMX4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Fig.2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632" y="13596"/>
            <a:ext cx="3424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Supplementary file 3A List of </a:t>
            </a:r>
            <a:r>
              <a:rPr lang="en-US" sz="800" i="1" dirty="0" smtClean="0">
                <a:latin typeface="Helvetica"/>
                <a:cs typeface="Helvetica"/>
              </a:rPr>
              <a:t>S. </a:t>
            </a:r>
            <a:r>
              <a:rPr lang="en-US" sz="800" i="1" dirty="0" err="1" smtClean="0">
                <a:latin typeface="Helvetica"/>
                <a:cs typeface="Helvetica"/>
              </a:rPr>
              <a:t>cerevisiae</a:t>
            </a:r>
            <a:r>
              <a:rPr lang="en-US" sz="800" i="1" dirty="0" smtClean="0">
                <a:latin typeface="Helvetica"/>
                <a:cs typeface="Helvetica"/>
              </a:rPr>
              <a:t> </a:t>
            </a:r>
            <a:r>
              <a:rPr lang="en-US" sz="800" dirty="0" smtClean="0">
                <a:latin typeface="Helvetica"/>
                <a:cs typeface="Helvetica"/>
              </a:rPr>
              <a:t>strains</a:t>
            </a:r>
            <a:endParaRPr lang="en-US" sz="800" i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356112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3028517"/>
              </p:ext>
            </p:extLst>
          </p:nvPr>
        </p:nvGraphicFramePr>
        <p:xfrm>
          <a:off x="158749" y="305240"/>
          <a:ext cx="4333654" cy="3081496"/>
        </p:xfrm>
        <a:graphic>
          <a:graphicData uri="http://schemas.openxmlformats.org/drawingml/2006/table">
            <a:tbl>
              <a:tblPr/>
              <a:tblGrid>
                <a:gridCol w="1188059"/>
                <a:gridCol w="2169442"/>
                <a:gridCol w="976153"/>
              </a:tblGrid>
              <a:tr h="280136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lasmi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Genotyp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Sourc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YES2</a:t>
                      </a:r>
                      <a:r>
                        <a:rPr lang="en-US" sz="700" b="0" i="0" u="none" strike="noStrike" kern="1200" baseline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mHtt103QP</a:t>
                      </a: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GF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YES2-GAL1-FLAG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mHtt103QP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GFP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U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RA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Meriin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., 200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Y2H</a:t>
                      </a:r>
                      <a:r>
                        <a:rPr lang="en-US" sz="700" b="0" i="0" u="none" strike="noStrike" kern="1200" baseline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mHtt103QP</a:t>
                      </a: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-GFP 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YES2-GAL1-FLAG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mHtt103QP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GFP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H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hMX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YES2-GFP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YES2-GAL1-GFP URA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reveral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,. 200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rgbClr val="000000"/>
                          </a:solidFill>
                          <a:latin typeface="Helvetica"/>
                          <a:ea typeface="+mn-ea"/>
                          <a:cs typeface="Helvetica"/>
                        </a:rPr>
                        <a:t>pY2H-GFP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YES2-GAL1-GFP HphMX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his study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GAD-LTN1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ADH1 HA-Ltn1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LEU2 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engtson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,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. 201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GAD-LTN1</a:t>
                      </a:r>
                      <a:r>
                        <a:rPr lang="en-US" sz="7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sz="7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W1542E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2μ pADH1 HA-Ltn1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W1542E LEU2 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engtson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.</a:t>
                      </a:r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, 2010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RS416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EN UR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ab stock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RS416-TEF1-HSF1-R206S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EN pRS416-TEF1-HSF1-R206S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URA</a:t>
                      </a:r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Hou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., 201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pESC-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UBC9</a:t>
                      </a:r>
                      <a:r>
                        <a:rPr lang="en-US" sz="10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ts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mCherry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2μ pGAL1-UBC9-ts-mCherry URA3 </a:t>
                      </a:r>
                      <a:endParaRPr lang="en-US" sz="700" b="0" i="0" u="none" strike="noStrike" baseline="0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kern="1200" baseline="0" dirty="0" err="1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Kaganovich</a:t>
                      </a:r>
                      <a:r>
                        <a:rPr lang="en-US" sz="700" b="0" i="0" u="none" strike="noStrike" kern="1200" baseline="0" dirty="0" smtClean="0">
                          <a:solidFill>
                            <a:schemeClr val="tx1"/>
                          </a:solidFill>
                          <a:latin typeface="Helvetica"/>
                          <a:ea typeface="+mn-ea"/>
                          <a:cs typeface="Helvetica"/>
                        </a:rPr>
                        <a:t> et al., 200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136"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200" dirty="0" err="1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pADH</a:t>
                      </a:r>
                      <a:r>
                        <a:rPr lang="en-US" altLang="zh-CN" sz="700" kern="1200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-His-</a:t>
                      </a:r>
                      <a:r>
                        <a:rPr lang="en-US" altLang="zh-CN" sz="700" kern="1200" dirty="0" err="1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Ub</a:t>
                      </a:r>
                      <a:r>
                        <a:rPr lang="en-US" altLang="zh-CN" sz="700" kern="1200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endParaRPr lang="en-US" sz="700" b="0" i="0" u="none" strike="noStrike" baseline="0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kern="1200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ADH-His-</a:t>
                      </a:r>
                      <a:r>
                        <a:rPr lang="en-US" altLang="zh-CN" sz="700" kern="1200" dirty="0" err="1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Ub</a:t>
                      </a:r>
                      <a:r>
                        <a:rPr lang="en-US" altLang="zh-CN" sz="700" kern="1200" dirty="0" smtClean="0">
                          <a:solidFill>
                            <a:schemeClr val="tx1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 </a:t>
                      </a:r>
                      <a:r>
                        <a:rPr lang="en-US" altLang="zh-CN" sz="7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LEU2</a:t>
                      </a:r>
                      <a:endParaRPr lang="en-US" altLang="zh-CN" sz="700" b="0" i="0" u="none" strike="noStrike" baseline="0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spcBef>
                          <a:spcPts val="0"/>
                        </a:spcBef>
                      </a:pP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Lu</a:t>
                      </a:r>
                      <a:r>
                        <a:rPr lang="en-US" sz="7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t al., 201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632" y="13596"/>
            <a:ext cx="3424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Supplementary file 3B List of plasmids.</a:t>
            </a:r>
            <a:endParaRPr lang="en-US" sz="800" i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537039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>
          <a:tailEnd type="arrow"/>
        </a:ln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5</TotalTime>
  <Words>759</Words>
  <Application>Microsoft Macintosh PowerPoint</Application>
  <PresentationFormat>On-screen Show (4:3)</PresentationFormat>
  <Paragraphs>19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G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Nyström</dc:creator>
  <cp:lastModifiedBy>Junsheng Yang</cp:lastModifiedBy>
  <cp:revision>1213</cp:revision>
  <cp:lastPrinted>2014-10-20T06:32:57Z</cp:lastPrinted>
  <dcterms:created xsi:type="dcterms:W3CDTF">2013-02-25T19:20:10Z</dcterms:created>
  <dcterms:modified xsi:type="dcterms:W3CDTF">2016-02-22T03:39:02Z</dcterms:modified>
</cp:coreProperties>
</file>